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48" autoAdjust="0"/>
    <p:restoredTop sz="94660"/>
  </p:normalViewPr>
  <p:slideViewPr>
    <p:cSldViewPr snapToGrid="0">
      <p:cViewPr varScale="1">
        <p:scale>
          <a:sx n="53" d="100"/>
          <a:sy n="53" d="100"/>
        </p:scale>
        <p:origin x="156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46947D-8B53-4E6F-2903-14E85158679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64EB4D9-05EC-5D4B-2AF4-BC8F2F5C60D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B1FE7D-D67E-92B2-D843-E998AF25B9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F65-895C-487D-B1C2-AED7CF452213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6C7FEC-29AD-A67D-55EB-64C5D20F86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9C70AC-DF2D-3DBC-3575-2E61417AF9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7D7A6-517D-43FF-8CA4-1E6E069DD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007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232B01-5C7C-56BC-2F6F-0A29DF84A2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44AC23C-8CB4-4158-F084-83C0B823AA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495E7E-AD28-1951-8732-37D658FA8B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F65-895C-487D-B1C2-AED7CF452213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8F1093-2A3D-0C7A-6CAC-454AD0B650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90CF22-4ECB-0546-A57F-29AE81357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7D7A6-517D-43FF-8CA4-1E6E069DD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401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E4E3BC9-24AB-2861-280C-5B023C8220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E38AEF9-5968-8E79-94A8-70B0F534BD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7F3A82-EC45-B4E5-BE1F-EDE37B564F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F65-895C-487D-B1C2-AED7CF452213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3CB4B8-7A82-11E2-051E-60ED85B28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36F73C-9B5A-ADA3-D937-DE3710F1BF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7D7A6-517D-43FF-8CA4-1E6E069DD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66296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C16700-8CF2-D208-9BA6-F553E8E6A6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E0DD51-E1F5-BFC3-E2C8-08849C451A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45197E-ED6A-50E4-745B-D4BA10F41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F65-895C-487D-B1C2-AED7CF452213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5363A9-ACDC-1BE5-F2B2-E5A83EDC7C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3E5545-56C0-576E-7588-C2A243510B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7D7A6-517D-43FF-8CA4-1E6E069DD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713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AA2C0B-0B49-10E4-CA11-8C5D518733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D0DAC7F-90F9-FF7A-6BAA-13CEAFB5DF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35F035-2C79-23A1-1EAC-AD1F60C6A4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F65-895C-487D-B1C2-AED7CF452213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6687D0-BD1C-F5D0-C8D4-B16A1C93A9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F3C332-EADB-8D96-32E6-528AC8A150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7D7A6-517D-43FF-8CA4-1E6E069DD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434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50F3FE-9068-803F-9327-69E28998BB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FF26CB-DF24-7E4A-61F9-1A40F9DEF5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568A8A-1FBD-40A1-9BEF-2F0AE0AF3F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38641E-D4D9-F8C1-85EB-6500DA72B5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F65-895C-487D-B1C2-AED7CF452213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792BE0-8C6F-268E-CF38-D7E918648A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75E0EE-8F44-D73D-3F97-CBEB61C20C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7D7A6-517D-43FF-8CA4-1E6E069DD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76132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904CB2-CF60-2EF9-DCF3-0A83D54ADB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5F5876-901A-E17E-E282-A8B90E96D3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0D01EA-BAE3-9A06-3941-B19201CBF5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B695223-E78A-3782-F68C-2FF48332D70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E383626-07E7-5B0A-3BAE-B53FAEB076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FA13BD3-7D19-F19F-3713-15DF4B8223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F65-895C-487D-B1C2-AED7CF452213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DE41F25-B36D-9646-AEE6-AC18CD8068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948CED7-2D06-C5AD-94A9-E0F5AB0370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7D7A6-517D-43FF-8CA4-1E6E069DD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1766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FBD874-7EBE-AE97-D28E-82502CD9CE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8B2CDB6-5E9A-5744-02C1-D5627DAAF4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F65-895C-487D-B1C2-AED7CF452213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861D486-8223-14FE-858F-426582B04C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96508C7-E9EB-4A53-BCF6-6EAC06BBC1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7D7A6-517D-43FF-8CA4-1E6E069DD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024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91ACD5B-F975-F79A-8A68-F896001F5D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F65-895C-487D-B1C2-AED7CF452213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5D45569-1913-16F7-A77F-87BB96541B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01DAF56-821E-2C6F-13DB-522DA83A51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7D7A6-517D-43FF-8CA4-1E6E069DD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285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E0929A-6DC6-3FE5-A390-8678E16D8E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B66F0D-0790-739A-A9A8-F50DA39111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A24A66B-0796-B0C5-ED95-A5E80B4970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715A8D-B00B-D815-F479-FA15532BA2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F65-895C-487D-B1C2-AED7CF452213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BA005A-29C0-1B9E-1A44-13060014F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C6EB1A-E9F2-0E73-4EE6-6D2AFE1B30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7D7A6-517D-43FF-8CA4-1E6E069DD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2797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ACE6B5-63F8-F7D0-7A63-2519344F42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B78EC30-612E-5C28-A578-B7B4D0B54F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B117F2-55FD-BA9C-EC68-41036DFE81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33D5100-2770-B77D-D2D7-7CA3795492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F65-895C-487D-B1C2-AED7CF452213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839CAE-B5E2-8B9C-1892-828AB41A6B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237AE4-1F34-9802-6623-439053C73A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7D7A6-517D-43FF-8CA4-1E6E069DD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28585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BF46E92-1938-626E-AFF1-860ACC3856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7E7A12-050E-7E5B-890B-CFF252DA2D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441101-8F8E-3A5D-B60F-AED729925D3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32B2F65-895C-487D-B1C2-AED7CF452213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89C5BB-FB81-747B-2A9B-01BE175F210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D163DB-FA3A-C7FF-733D-F96272E1E82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FE7D7A6-517D-43FF-8CA4-1E6E069DD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5045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ollage of images of a patient">
            <a:extLst>
              <a:ext uri="{FF2B5EF4-FFF2-40B4-BE49-F238E27FC236}">
                <a16:creationId xmlns:a16="http://schemas.microsoft.com/office/drawing/2014/main" id="{F6FC93CF-064B-66FB-ED35-653628EFA0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6193" y="0"/>
            <a:ext cx="7119613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BC28B0C-69E1-D56F-D426-4F6E48E70D24}"/>
              </a:ext>
            </a:extLst>
          </p:cNvPr>
          <p:cNvSpPr txBox="1"/>
          <p:nvPr/>
        </p:nvSpPr>
        <p:spPr>
          <a:xfrm>
            <a:off x="1993392" y="4828032"/>
            <a:ext cx="91074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1. CT images of target lesions at various time points during the HBV-TCR-T cell infusion. Day 0 marks the initiation of HBV-TCR-T treatment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891282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iegmann, Bill</dc:creator>
  <cp:lastModifiedBy>Siegmann, Bill</cp:lastModifiedBy>
  <cp:revision>1</cp:revision>
  <dcterms:created xsi:type="dcterms:W3CDTF">2025-07-21T15:55:39Z</dcterms:created>
  <dcterms:modified xsi:type="dcterms:W3CDTF">2025-07-21T15:56:52Z</dcterms:modified>
</cp:coreProperties>
</file>